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49E882F5-072D-DF4F-92E7-EF0AD4F7E177}">
          <p14:sldIdLst>
            <p14:sldId id="27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68B"/>
    <a:srgbClr val="FF24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9"/>
    <p:restoredTop sz="97674"/>
  </p:normalViewPr>
  <p:slideViewPr>
    <p:cSldViewPr snapToGrid="0">
      <p:cViewPr>
        <p:scale>
          <a:sx n="249" d="100"/>
          <a:sy n="249" d="100"/>
        </p:scale>
        <p:origin x="224" y="-100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E5109-D852-D04E-B9E8-0C8B47B42F75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60014-EC34-1548-9FB8-4F8B94B69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3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83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862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6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2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92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52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5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5C896AD-5352-4108-8A6F-BF03350B2C25}"/>
              </a:ext>
            </a:extLst>
          </p:cNvPr>
          <p:cNvSpPr txBox="1"/>
          <p:nvPr/>
        </p:nvSpPr>
        <p:spPr>
          <a:xfrm>
            <a:off x="0" y="0"/>
            <a:ext cx="2385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S1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156E004-39DD-6F9B-0B20-AFBD94DC027E}"/>
              </a:ext>
            </a:extLst>
          </p:cNvPr>
          <p:cNvSpPr txBox="1"/>
          <p:nvPr/>
        </p:nvSpPr>
        <p:spPr>
          <a:xfrm>
            <a:off x="112143" y="53483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03A9255-379D-7824-9699-FF020576F71E}"/>
              </a:ext>
            </a:extLst>
          </p:cNvPr>
          <p:cNvSpPr txBox="1"/>
          <p:nvPr/>
        </p:nvSpPr>
        <p:spPr>
          <a:xfrm>
            <a:off x="-3888" y="37177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A5B198C-402E-0BA0-F9C0-FCEA79C7D209}"/>
              </a:ext>
            </a:extLst>
          </p:cNvPr>
          <p:cNvSpPr txBox="1"/>
          <p:nvPr/>
        </p:nvSpPr>
        <p:spPr>
          <a:xfrm>
            <a:off x="3325481" y="37177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5577A7E-5DB0-27A7-D8B9-D1208F1B9CA8}"/>
              </a:ext>
            </a:extLst>
          </p:cNvPr>
          <p:cNvSpPr txBox="1"/>
          <p:nvPr/>
        </p:nvSpPr>
        <p:spPr>
          <a:xfrm>
            <a:off x="-3888" y="336012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E760061-ED02-2FA3-6784-2BFD2567DEF0}"/>
              </a:ext>
            </a:extLst>
          </p:cNvPr>
          <p:cNvSpPr txBox="1"/>
          <p:nvPr/>
        </p:nvSpPr>
        <p:spPr>
          <a:xfrm>
            <a:off x="3325481" y="336012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6757B3-5C55-DA84-757C-B716CCE7111C}"/>
              </a:ext>
            </a:extLst>
          </p:cNvPr>
          <p:cNvSpPr txBox="1"/>
          <p:nvPr/>
        </p:nvSpPr>
        <p:spPr>
          <a:xfrm>
            <a:off x="-3888" y="622415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FAB40E-A2E8-9FAC-C9D5-614851CB1EBC}"/>
              </a:ext>
            </a:extLst>
          </p:cNvPr>
          <p:cNvSpPr txBox="1"/>
          <p:nvPr/>
        </p:nvSpPr>
        <p:spPr>
          <a:xfrm>
            <a:off x="3325481" y="6224152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B0742EE5-6120-99B9-979E-B82356E76E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8664"/>
            <a:ext cx="3412890" cy="227526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0AAD06A7-0152-B1B9-E9CF-18EA601A2F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6487" y="722974"/>
            <a:ext cx="3412890" cy="227526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9B9165CF-28A5-8409-DE45-F6BA60E52F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3888" y="3729457"/>
            <a:ext cx="3412892" cy="2275261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CA2AE37B-7384-AF8A-B566-47D20AD834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09004" y="3729458"/>
            <a:ext cx="3412890" cy="227526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1F954585-7782-0D18-1081-2F3FF2B5697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23" y="6593483"/>
            <a:ext cx="3412893" cy="2275262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68C70990-163B-541C-B134-A20C9125438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36484" y="6593483"/>
            <a:ext cx="3412893" cy="227526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CB86FAA-8DB2-8560-85BF-EC6576C83D78}"/>
              </a:ext>
            </a:extLst>
          </p:cNvPr>
          <p:cNvSpPr txBox="1"/>
          <p:nvPr/>
        </p:nvSpPr>
        <p:spPr>
          <a:xfrm>
            <a:off x="8623" y="9106292"/>
            <a:ext cx="6813271" cy="7463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300"/>
              </a:spcBef>
            </a:pPr>
            <a:r>
              <a:rPr lang="en-US" sz="10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11. Individual TCR clonotypes </a:t>
            </a:r>
            <a:endParaRPr lang="fi-FI" sz="10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>
              <a:spcBef>
                <a:spcPts val="300"/>
              </a:spcBef>
            </a:pPr>
            <a:r>
              <a:rPr lang="en-US" sz="10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reemaps</a:t>
            </a:r>
            <a:r>
              <a:rPr lang="en-US" sz="1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howing the clonotype sizes (one box = one clonotype) in six patients:  A) pt096, B) pt115, C) pt125, D) pt423, E) pt426, and F) pt616) in each sample type (available healthy kidney, tumor, pre-REP TIL and REP TIL). Colored boxes indicate TCRs matched to viral-specific TCRs in VDJdb</a:t>
            </a:r>
            <a:r>
              <a:rPr lang="en-US" sz="10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</a:t>
            </a:r>
            <a:r>
              <a:rPr lang="en-US" sz="1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Few matches were discovered and represented small T-cell clonotypes.</a:t>
            </a:r>
            <a:endParaRPr lang="fi-FI" sz="10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6561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90</TotalTime>
  <Words>96</Words>
  <Application>Microsoft Macintosh PowerPoint</Application>
  <PresentationFormat>A4-paperi (210 x 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4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esit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Moon Hee</dc:creator>
  <cp:lastModifiedBy>Mustjoki, Satu M</cp:lastModifiedBy>
  <cp:revision>395</cp:revision>
  <dcterms:created xsi:type="dcterms:W3CDTF">2022-10-13T13:05:53Z</dcterms:created>
  <dcterms:modified xsi:type="dcterms:W3CDTF">2023-06-17T07:33:28Z</dcterms:modified>
</cp:coreProperties>
</file>